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jpeg" ContentType="image/jpeg"/>
  <Override PartName="/ppt/media/image9.jpeg" ContentType="image/jpeg"/>
  <Override PartName="/ppt/media/image10.jpeg" ContentType="image/jpeg"/>
  <Override PartName="/ppt/media/image5.png" ContentType="image/png"/>
  <Override PartName="/ppt/media/image8.jpeg" ContentType="image/jpeg"/>
  <Override PartName="/ppt/media/image12.jpeg" ContentType="image/jpeg"/>
  <Override PartName="/ppt/media/image7.jpeg" ContentType="image/jpeg"/>
  <Override PartName="/ppt/media/image6.png" ContentType="image/png"/>
  <Override PartName="/ppt/media/image13.jpeg" ContentType="image/jpeg"/>
  <Override PartName="/ppt/media/image23.png" ContentType="image/png"/>
  <Override PartName="/ppt/media/image22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8.jpeg" ContentType="image/jpeg"/>
  <Override PartName="/ppt/media/image14.jpeg" ContentType="image/jpeg"/>
  <Override PartName="/ppt/media/image2.png" ContentType="image/png"/>
  <Override PartName="/ppt/media/image1.png" ContentType="image/png"/>
  <Override PartName="/ppt/media/image17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907588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17968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714760" y="514440"/>
            <a:ext cx="3714480" cy="2571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17968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5D5AB24-269A-4417-8E5B-1C2823FB0991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2714760" y="514440"/>
            <a:ext cx="3714480" cy="257184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Slide Number Placeholder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AA7E7A8-0739-404D-82DB-1CE44CF8E280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2900520" y="857160"/>
            <a:ext cx="3342960" cy="231480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Segnaposto numero diapositiva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8D9D208-B85D-415E-B6AB-FEF3B6E744CA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sldImg"/>
          </p:nvPr>
        </p:nvSpPr>
        <p:spPr>
          <a:xfrm>
            <a:off x="2900520" y="857160"/>
            <a:ext cx="3342960" cy="2314800"/>
          </a:xfrm>
          <a:prstGeom prst="rect">
            <a:avLst/>
          </a:prstGeom>
          <a:ln w="0">
            <a:noFill/>
          </a:ln>
        </p:spPr>
      </p:sp>
      <p:sp>
        <p:nvSpPr>
          <p:cNvPr id="130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Segnaposto numero diapositiva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31AB180-A819-4EE0-9E57-73B9187B692B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sldImg"/>
          </p:nvPr>
        </p:nvSpPr>
        <p:spPr>
          <a:xfrm>
            <a:off x="2900520" y="857160"/>
            <a:ext cx="3342960" cy="2314800"/>
          </a:xfrm>
          <a:prstGeom prst="rect">
            <a:avLst/>
          </a:prstGeom>
          <a:ln w="0">
            <a:noFill/>
          </a:ln>
        </p:spPr>
      </p:sp>
      <p:sp>
        <p:nvSpPr>
          <p:cNvPr id="133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Segnaposto numero diapositiva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49F6D46-C9C4-44F3-BB73-541945ACF553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sldImg"/>
          </p:nvPr>
        </p:nvSpPr>
        <p:spPr>
          <a:xfrm>
            <a:off x="2900520" y="857160"/>
            <a:ext cx="3342960" cy="2314800"/>
          </a:xfrm>
          <a:prstGeom prst="rect">
            <a:avLst/>
          </a:prstGeom>
          <a:ln w="0">
            <a:noFill/>
          </a:ln>
        </p:spPr>
      </p:sp>
      <p:sp>
        <p:nvSpPr>
          <p:cNvPr id="136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Segnaposto numero diapositiva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873C0F0-16E4-4111-8E3B-328220242002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121E6-4EA3-4709-9FB7-67EB45CDDA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6C81F4-94E9-48DB-967C-694282AD18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F8588-8A66-40F2-8951-1C97DFFB50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F6EF5-B158-46F7-8FC2-EB426E7CA0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3B1F4B-3A47-4C0F-855A-00819EF537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B7613-FDC8-418B-9BE1-8DAC2C4553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52FE0-A9C6-40F9-9280-46847A20F9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0C343-1448-43D5-933B-62E0C74E46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B4988-6974-480F-A22C-B65663DA69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94D6E-18BC-4179-9FA6-47327DEAA3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D6192-5C6C-45A1-819D-902A36EAE8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41519-E4E6-4D0C-AEE1-AD685FBFBC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D57E7ED-C91A-497C-9E9D-6CA51332AAE8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image" Target="../media/image10.jpeg"/><Relationship Id="rId4" Type="http://schemas.openxmlformats.org/officeDocument/2006/relationships/image" Target="../media/image10.jpe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image" Target="../media/image17.jpeg"/><Relationship Id="rId4" Type="http://schemas.openxmlformats.org/officeDocument/2006/relationships/image" Target="../media/image18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image" Target="../media/image21.jpeg"/><Relationship Id="rId4" Type="http://schemas.openxmlformats.org/officeDocument/2006/relationships/image" Target="../media/image22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95000" y="228096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4400" spc="-1" strike="noStrike">
                <a:solidFill>
                  <a:srgbClr val="000000"/>
                </a:solidFill>
                <a:latin typeface="Calibri"/>
              </a:rPr>
              <a:t>Supplemental file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52280" y="6133680"/>
            <a:ext cx="9753840" cy="561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bbreviatio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- ETG: trans-rectal ultrasound; MR: magnetic resonance; Obs: observer. </a:t>
            </a:r>
            <a:r>
              <a:rPr b="0" lang="en-GB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Symbol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mr-IN" sz="12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square: FIGO I; circle: FIGO II; triangle </a:t>
            </a:r>
            <a:r>
              <a:rPr b="0" lang="mr-IN" sz="12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FIGO III; diamond: FIGO IV. NOTE: in Bland Altman plot, solid line represents average, thick doted line represents 2SD (standard deviation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ontent Placeholder 11" descr="Screen Shot 2017-01-30 at 08.56.54.png"/>
          <p:cNvPicPr/>
          <p:nvPr/>
        </p:nvPicPr>
        <p:blipFill>
          <a:blip r:embed="rId1"/>
          <a:srcRect l="0" t="-23955" r="0" b="-23955"/>
          <a:stretch/>
        </p:blipFill>
        <p:spPr>
          <a:xfrm>
            <a:off x="1811160" y="395280"/>
            <a:ext cx="3063960" cy="2462400"/>
          </a:xfrm>
          <a:prstGeom prst="rect">
            <a:avLst/>
          </a:prstGeom>
          <a:ln w="0">
            <a:noFill/>
          </a:ln>
        </p:spPr>
      </p:pic>
      <p:pic>
        <p:nvPicPr>
          <p:cNvPr id="51" name="Content Placeholder 10" descr="Screen Shot 2017-01-30 at 08.56.09.png"/>
          <p:cNvPicPr/>
          <p:nvPr/>
        </p:nvPicPr>
        <p:blipFill>
          <a:blip r:embed="rId2"/>
          <a:srcRect l="0" t="-24172" r="0" b="-24172"/>
          <a:stretch/>
        </p:blipFill>
        <p:spPr>
          <a:xfrm>
            <a:off x="6346800" y="395280"/>
            <a:ext cx="3063960" cy="2462400"/>
          </a:xfrm>
          <a:prstGeom prst="rect">
            <a:avLst/>
          </a:prstGeom>
          <a:ln w="0">
            <a:noFill/>
          </a:ln>
        </p:spPr>
      </p:pic>
      <p:pic>
        <p:nvPicPr>
          <p:cNvPr id="52" name="Content Placeholder 3" descr="Screen Shot 2017-01-30 at 08.58.16.png"/>
          <p:cNvPicPr/>
          <p:nvPr/>
        </p:nvPicPr>
        <p:blipFill>
          <a:blip r:embed="rId3"/>
          <a:srcRect l="0" t="-23728" r="0" b="-23728"/>
          <a:stretch/>
        </p:blipFill>
        <p:spPr>
          <a:xfrm>
            <a:off x="6346800" y="2127240"/>
            <a:ext cx="3063960" cy="2463840"/>
          </a:xfrm>
          <a:prstGeom prst="rect">
            <a:avLst/>
          </a:prstGeom>
          <a:ln w="0">
            <a:noFill/>
          </a:ln>
        </p:spPr>
      </p:pic>
      <p:pic>
        <p:nvPicPr>
          <p:cNvPr id="53" name="Content Placeholder 7" descr="Screen Shot 2017-01-30 at 08.58.26.png"/>
          <p:cNvPicPr/>
          <p:nvPr/>
        </p:nvPicPr>
        <p:blipFill>
          <a:blip r:embed="rId4"/>
          <a:srcRect l="0" t="-21854" r="0" b="-21854"/>
          <a:stretch/>
        </p:blipFill>
        <p:spPr>
          <a:xfrm>
            <a:off x="1811160" y="2136600"/>
            <a:ext cx="3063960" cy="2463840"/>
          </a:xfrm>
          <a:prstGeom prst="rect">
            <a:avLst/>
          </a:prstGeom>
          <a:ln w="0">
            <a:noFill/>
          </a:ln>
        </p:spPr>
      </p:pic>
      <p:pic>
        <p:nvPicPr>
          <p:cNvPr id="54" name="Content Placeholder 6" descr="Screen Shot 2017-01-30 at 09.00.42.png"/>
          <p:cNvPicPr/>
          <p:nvPr/>
        </p:nvPicPr>
        <p:blipFill>
          <a:blip r:embed="rId5"/>
          <a:srcRect l="0" t="-22889" r="0" b="-22889"/>
          <a:stretch/>
        </p:blipFill>
        <p:spPr>
          <a:xfrm>
            <a:off x="1811160" y="4092480"/>
            <a:ext cx="3063960" cy="2336760"/>
          </a:xfrm>
          <a:prstGeom prst="rect">
            <a:avLst/>
          </a:prstGeom>
          <a:ln w="0">
            <a:noFill/>
          </a:ln>
        </p:spPr>
      </p:pic>
      <p:pic>
        <p:nvPicPr>
          <p:cNvPr id="55" name="Content Placeholder 4" descr="Screen Shot 2017-01-30 at 09.00.32.png"/>
          <p:cNvPicPr/>
          <p:nvPr/>
        </p:nvPicPr>
        <p:blipFill>
          <a:blip r:embed="rId6"/>
          <a:srcRect l="0" t="-21580" r="0" b="-21580"/>
          <a:stretch/>
        </p:blipFill>
        <p:spPr>
          <a:xfrm>
            <a:off x="6346800" y="4092480"/>
            <a:ext cx="3063960" cy="2336760"/>
          </a:xfrm>
          <a:prstGeom prst="rect">
            <a:avLst/>
          </a:prstGeom>
          <a:ln w="0">
            <a:noFill/>
          </a:ln>
        </p:spPr>
      </p:pic>
      <p:sp>
        <p:nvSpPr>
          <p:cNvPr id="56" name="TextBox 1"/>
          <p:cNvSpPr/>
          <p:nvPr/>
        </p:nvSpPr>
        <p:spPr>
          <a:xfrm>
            <a:off x="495360" y="1370160"/>
            <a:ext cx="1425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Obs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9"/>
          <p:cNvSpPr/>
          <p:nvPr/>
        </p:nvSpPr>
        <p:spPr>
          <a:xfrm>
            <a:off x="495360" y="3032280"/>
            <a:ext cx="1425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Obs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2"/>
          <p:cNvSpPr/>
          <p:nvPr/>
        </p:nvSpPr>
        <p:spPr>
          <a:xfrm>
            <a:off x="495360" y="5022720"/>
            <a:ext cx="1425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Obs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"/>
          <p:cNvSpPr/>
          <p:nvPr/>
        </p:nvSpPr>
        <p:spPr>
          <a:xfrm>
            <a:off x="6721560" y="395280"/>
            <a:ext cx="268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Bland Altman Plot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"/>
          <p:cNvSpPr/>
          <p:nvPr/>
        </p:nvSpPr>
        <p:spPr>
          <a:xfrm>
            <a:off x="2038320" y="395280"/>
            <a:ext cx="30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Passing–Bablok Regress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1 – Intra-observer variability analysi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"/>
          <p:cNvSpPr/>
          <p:nvPr/>
        </p:nvSpPr>
        <p:spPr>
          <a:xfrm>
            <a:off x="3083040" y="1792440"/>
            <a:ext cx="255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-1,16 (CI 95%: -3,83 – 0,75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1,05 (CI 95%: 1 – 1,11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5"/>
          <p:cNvSpPr/>
          <p:nvPr/>
        </p:nvSpPr>
        <p:spPr>
          <a:xfrm>
            <a:off x="3075120" y="3541680"/>
            <a:ext cx="255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-0,08 (CI 95%: -1,42 – 1,3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1,01 (CI 95%: 0,98 – 1,0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6"/>
          <p:cNvSpPr/>
          <p:nvPr/>
        </p:nvSpPr>
        <p:spPr>
          <a:xfrm>
            <a:off x="3070080" y="5397480"/>
            <a:ext cx="25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-2,06 (CI 95%: -4,18 – 0,26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1,05 (CI 95%: 1,00 – 1,11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itle 5"/>
          <p:cNvSpPr/>
          <p:nvPr/>
        </p:nvSpPr>
        <p:spPr>
          <a:xfrm>
            <a:off x="0" y="6121440"/>
            <a:ext cx="9813960" cy="97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3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bbreviation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M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: high-risk clinical target volume in Magnetic Resonance;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TRU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: high-risk clinical target volume in trans-rectal ultrasound; In the table are shown the percentage (%) of patients with the respective differences between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M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and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TRU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6" name=""/>
          <p:cNvGraphicFramePr/>
          <p:nvPr/>
        </p:nvGraphicFramePr>
        <p:xfrm>
          <a:off x="247680" y="1344600"/>
          <a:ext cx="3981600" cy="3659040"/>
        </p:xfrm>
        <a:graphic>
          <a:graphicData uri="http://schemas.openxmlformats.org/drawingml/2006/table">
            <a:tbl>
              <a:tblPr/>
              <a:tblGrid>
                <a:gridCol w="995400"/>
                <a:gridCol w="995400"/>
                <a:gridCol w="995400"/>
                <a:gridCol w="995400"/>
              </a:tblGrid>
              <a:tr h="52236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BS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BS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BS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38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- 5 m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2236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4.99 to -3 m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236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2.99 to 0 m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20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0.01 to 3 m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416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3.01 to 5 m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20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 5 m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7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2.1  – Overall </a:t>
            </a: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width difference between HRCTV</a:t>
            </a:r>
            <a:r>
              <a:rPr b="1" lang="en-US" sz="2000" spc="-1" strike="noStrike" baseline="-25000">
                <a:solidFill>
                  <a:srgbClr val="ffffff"/>
                </a:solidFill>
                <a:latin typeface="Times New Roman"/>
                <a:ea typeface="Times New Roman"/>
              </a:rPr>
              <a:t>MR</a:t>
            </a: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 and HRCTV</a:t>
            </a:r>
            <a:r>
              <a:rPr b="1" lang="en-US" sz="2000" spc="-1" strike="noStrike" baseline="-25000">
                <a:solidFill>
                  <a:srgbClr val="ffffff"/>
                </a:solidFill>
                <a:latin typeface="Times New Roman"/>
                <a:ea typeface="Times New Roman"/>
              </a:rPr>
              <a:t>TRUS</a:t>
            </a: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2" descr="OVERALL 3 observers.jpg"/>
          <p:cNvPicPr/>
          <p:nvPr/>
        </p:nvPicPr>
        <p:blipFill>
          <a:blip r:embed="rId1"/>
          <a:stretch/>
        </p:blipFill>
        <p:spPr>
          <a:xfrm>
            <a:off x="4718160" y="1735200"/>
            <a:ext cx="4930560" cy="3471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3" descr="OBS 2.jpg"/>
          <p:cNvPicPr/>
          <p:nvPr/>
        </p:nvPicPr>
        <p:blipFill>
          <a:blip r:embed="rId1"/>
          <a:srcRect l="0" t="0" r="20798" b="0"/>
          <a:stretch/>
        </p:blipFill>
        <p:spPr>
          <a:xfrm>
            <a:off x="3265560" y="471600"/>
            <a:ext cx="3171600" cy="27716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" descr="OBS 1.jpg"/>
          <p:cNvPicPr/>
          <p:nvPr/>
        </p:nvPicPr>
        <p:blipFill>
          <a:blip r:embed="rId2"/>
          <a:srcRect l="0" t="0" r="19443" b="0"/>
          <a:stretch/>
        </p:blipFill>
        <p:spPr>
          <a:xfrm>
            <a:off x="0" y="503280"/>
            <a:ext cx="3189240" cy="27399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4" descr="OBS 3.jpg"/>
          <p:cNvPicPr/>
          <p:nvPr/>
        </p:nvPicPr>
        <p:blipFill>
          <a:blip r:embed="rId3"/>
          <a:srcRect l="0" t="0" r="22005" b="0"/>
          <a:stretch/>
        </p:blipFill>
        <p:spPr>
          <a:xfrm>
            <a:off x="6541920" y="471600"/>
            <a:ext cx="3122640" cy="2771640"/>
          </a:xfrm>
          <a:prstGeom prst="rect">
            <a:avLst/>
          </a:prstGeom>
          <a:ln w="0">
            <a:noFill/>
          </a:ln>
        </p:spPr>
      </p:pic>
      <p:sp>
        <p:nvSpPr>
          <p:cNvPr id="72" name="Title 5"/>
          <p:cNvSpPr/>
          <p:nvPr/>
        </p:nvSpPr>
        <p:spPr>
          <a:xfrm>
            <a:off x="0" y="6121440"/>
            <a:ext cx="9813960" cy="97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3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bbreviation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M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: high-risk clinical target volume in Magnetic Resonance;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TRU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: high-risk clinical target volume in trans-rectal ultrasound; FIGO - International Federation of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Gynaecology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nd Obstetric. In the tables, are shown the percentage (%) of patients with the respective differences between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M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and HRCTV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TRU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6" descr="OBS 3.jpg"/>
          <p:cNvPicPr/>
          <p:nvPr/>
        </p:nvPicPr>
        <p:blipFill>
          <a:blip r:embed="rId4"/>
          <a:srcRect l="77997" t="9321" r="0" b="57518"/>
          <a:stretch/>
        </p:blipFill>
        <p:spPr>
          <a:xfrm>
            <a:off x="9151920" y="701640"/>
            <a:ext cx="568440" cy="642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aphicFrame>
        <p:nvGraphicFramePr>
          <p:cNvPr id="74" name=""/>
          <p:cNvGraphicFramePr/>
          <p:nvPr/>
        </p:nvGraphicFramePr>
        <p:xfrm>
          <a:off x="69840" y="3597120"/>
          <a:ext cx="3195720" cy="2444760"/>
        </p:xfrm>
        <a:graphic>
          <a:graphicData uri="http://schemas.openxmlformats.org/drawingml/2006/table">
            <a:tbl>
              <a:tblPr/>
              <a:tblGrid>
                <a:gridCol w="639720"/>
                <a:gridCol w="638280"/>
                <a:gridCol w="639720"/>
                <a:gridCol w="638280"/>
                <a:gridCol w="639720"/>
              </a:tblGrid>
              <a:tr h="34956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-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4.99 to -3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2.99 to 0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,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,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0.01 to 3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,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3.01 to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,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5" name=""/>
          <p:cNvGraphicFramePr/>
          <p:nvPr/>
        </p:nvGraphicFramePr>
        <p:xfrm>
          <a:off x="3346560" y="3594240"/>
          <a:ext cx="3195360" cy="2446200"/>
        </p:xfrm>
        <a:graphic>
          <a:graphicData uri="http://schemas.openxmlformats.org/drawingml/2006/table">
            <a:tbl>
              <a:tblPr/>
              <a:tblGrid>
                <a:gridCol w="639720"/>
                <a:gridCol w="638280"/>
                <a:gridCol w="639720"/>
                <a:gridCol w="637920"/>
                <a:gridCol w="639720"/>
              </a:tblGrid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-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4.99 to -3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510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2.99 to 0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,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,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0.01 to 3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,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,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,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3.01 to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,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6" name=""/>
          <p:cNvGraphicFramePr/>
          <p:nvPr/>
        </p:nvGraphicFramePr>
        <p:xfrm>
          <a:off x="6618240" y="3597120"/>
          <a:ext cx="3195720" cy="2444760"/>
        </p:xfrm>
        <a:graphic>
          <a:graphicData uri="http://schemas.openxmlformats.org/drawingml/2006/table">
            <a:tbl>
              <a:tblPr/>
              <a:tblGrid>
                <a:gridCol w="639720"/>
                <a:gridCol w="638280"/>
                <a:gridCol w="639720"/>
                <a:gridCol w="638280"/>
                <a:gridCol w="639720"/>
              </a:tblGrid>
              <a:tr h="34956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I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-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4.99 to -3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,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-2.99 to 0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,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,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,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0.01 to 3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,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,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m 3.01 to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,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 5 m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,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9000" rIns="99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9000" marR="9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7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2.2  – </a:t>
            </a: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Width difference between HRCTV</a:t>
            </a:r>
            <a:r>
              <a:rPr b="1" lang="en-US" sz="2000" spc="-1" strike="noStrike" baseline="-25000">
                <a:solidFill>
                  <a:srgbClr val="ffffff"/>
                </a:solidFill>
                <a:latin typeface="Times New Roman"/>
                <a:ea typeface="Times New Roman"/>
              </a:rPr>
              <a:t>MR</a:t>
            </a: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 and HRCTV</a:t>
            </a:r>
            <a:r>
              <a:rPr b="1" lang="en-US" sz="2000" spc="-1" strike="noStrike" baseline="-25000">
                <a:solidFill>
                  <a:srgbClr val="ffffff"/>
                </a:solidFill>
                <a:latin typeface="Times New Roman"/>
                <a:ea typeface="Times New Roman"/>
              </a:rPr>
              <a:t>TRUS</a:t>
            </a: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, by stag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Immagine 13" descr=""/>
          <p:cNvPicPr/>
          <p:nvPr/>
        </p:nvPicPr>
        <p:blipFill>
          <a:blip r:embed="rId1"/>
          <a:stretch/>
        </p:blipFill>
        <p:spPr>
          <a:xfrm>
            <a:off x="4665600" y="527040"/>
            <a:ext cx="3529080" cy="2936880"/>
          </a:xfrm>
          <a:prstGeom prst="rect">
            <a:avLst/>
          </a:prstGeom>
          <a:ln w="0">
            <a:noFill/>
          </a:ln>
        </p:spPr>
      </p:pic>
      <p:pic>
        <p:nvPicPr>
          <p:cNvPr id="79" name="Immagine 8" descr=""/>
          <p:cNvPicPr/>
          <p:nvPr/>
        </p:nvPicPr>
        <p:blipFill>
          <a:blip r:embed="rId2"/>
          <a:stretch/>
        </p:blipFill>
        <p:spPr>
          <a:xfrm>
            <a:off x="1436760" y="542880"/>
            <a:ext cx="3422520" cy="2989440"/>
          </a:xfrm>
          <a:prstGeom prst="rect">
            <a:avLst/>
          </a:prstGeom>
          <a:ln w="0">
            <a:noFill/>
          </a:ln>
        </p:spPr>
      </p:pic>
      <p:pic>
        <p:nvPicPr>
          <p:cNvPr id="80" name="Immagine 18" descr=""/>
          <p:cNvPicPr/>
          <p:nvPr/>
        </p:nvPicPr>
        <p:blipFill>
          <a:blip r:embed="rId3"/>
          <a:srcRect l="-6014" t="0" r="2" b="0"/>
          <a:stretch/>
        </p:blipFill>
        <p:spPr>
          <a:xfrm>
            <a:off x="1436760" y="3533760"/>
            <a:ext cx="3392280" cy="3121200"/>
          </a:xfrm>
          <a:prstGeom prst="rect">
            <a:avLst/>
          </a:prstGeom>
          <a:ln w="0">
            <a:noFill/>
          </a:ln>
        </p:spPr>
      </p:pic>
      <p:pic>
        <p:nvPicPr>
          <p:cNvPr id="81" name="Immagine 21" descr=""/>
          <p:cNvPicPr/>
          <p:nvPr/>
        </p:nvPicPr>
        <p:blipFill>
          <a:blip r:embed="rId4"/>
          <a:srcRect l="5709" t="0" r="5709" b="0"/>
          <a:stretch/>
        </p:blipFill>
        <p:spPr>
          <a:xfrm>
            <a:off x="5041800" y="3649680"/>
            <a:ext cx="3033720" cy="2811600"/>
          </a:xfrm>
          <a:prstGeom prst="rect">
            <a:avLst/>
          </a:prstGeom>
          <a:ln w="0">
            <a:noFill/>
          </a:ln>
        </p:spPr>
      </p:pic>
      <p:sp>
        <p:nvSpPr>
          <p:cNvPr id="82" name="Title 5"/>
          <p:cNvSpPr/>
          <p:nvPr/>
        </p:nvSpPr>
        <p:spPr>
          <a:xfrm>
            <a:off x="133200" y="6364440"/>
            <a:ext cx="9772920" cy="44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bbreviation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Obs: observer; CI: confidence interval.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Symbols </a:t>
            </a:r>
            <a:r>
              <a:rPr b="0" lang="mr-IN" sz="11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square: FIGO I; circle: FIGO II; triangle </a:t>
            </a:r>
            <a:r>
              <a:rPr b="0" lang="mr-IN" sz="11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FIGO III; diamond: FIGO IV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NOTE: in Bland Altman plot, solid line represents average, thick doted line represents 2SD (SD: standard deviation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3.1 – Inter-observer agreement analysis (Obs 1 vs Obs 2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2"/>
          <p:cNvSpPr/>
          <p:nvPr/>
        </p:nvSpPr>
        <p:spPr>
          <a:xfrm>
            <a:off x="5183280" y="736560"/>
            <a:ext cx="26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d Altman P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"/>
          <p:cNvSpPr/>
          <p:nvPr/>
        </p:nvSpPr>
        <p:spPr>
          <a:xfrm>
            <a:off x="1847880" y="739800"/>
            <a:ext cx="28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ssing–Bablok Reg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2"/>
          <p:cNvSpPr/>
          <p:nvPr/>
        </p:nvSpPr>
        <p:spPr>
          <a:xfrm>
            <a:off x="5348160" y="3753000"/>
            <a:ext cx="26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d Altman P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3"/>
          <p:cNvSpPr/>
          <p:nvPr/>
        </p:nvSpPr>
        <p:spPr>
          <a:xfrm>
            <a:off x="2013120" y="3755880"/>
            <a:ext cx="28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ssing–Bablok Reg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CasellaDiTesto 6"/>
          <p:cNvSpPr/>
          <p:nvPr/>
        </p:nvSpPr>
        <p:spPr>
          <a:xfrm>
            <a:off x="1300320" y="498600"/>
            <a:ext cx="7118280" cy="3070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BT M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CasellaDiTesto 6"/>
          <p:cNvSpPr/>
          <p:nvPr/>
        </p:nvSpPr>
        <p:spPr>
          <a:xfrm>
            <a:off x="1300320" y="3456000"/>
            <a:ext cx="7118280" cy="3070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BT TRU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28"/>
          <p:cNvSpPr/>
          <p:nvPr/>
        </p:nvSpPr>
        <p:spPr>
          <a:xfrm>
            <a:off x="2927520" y="5665680"/>
            <a:ext cx="2252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-2,06 (CI 95%: -7,48 – 2,39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1,01 (CI 95%: 0,92 – 1,1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29"/>
          <p:cNvSpPr/>
          <p:nvPr/>
        </p:nvSpPr>
        <p:spPr>
          <a:xfrm>
            <a:off x="2870280" y="2627280"/>
            <a:ext cx="2252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-2,04 (CI 95%: -5,41 – 1,4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0,99 (CI 95%: 0,91 – 1,08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Immagine 22" descr=""/>
          <p:cNvPicPr/>
          <p:nvPr/>
        </p:nvPicPr>
        <p:blipFill>
          <a:blip r:embed="rId1"/>
          <a:stretch/>
        </p:blipFill>
        <p:spPr>
          <a:xfrm>
            <a:off x="5327640" y="3665520"/>
            <a:ext cx="2921040" cy="2844720"/>
          </a:xfrm>
          <a:prstGeom prst="rect">
            <a:avLst/>
          </a:prstGeom>
          <a:ln w="0">
            <a:noFill/>
          </a:ln>
        </p:spPr>
      </p:pic>
      <p:pic>
        <p:nvPicPr>
          <p:cNvPr id="93" name="Immagine 19" descr=""/>
          <p:cNvPicPr/>
          <p:nvPr/>
        </p:nvPicPr>
        <p:blipFill>
          <a:blip r:embed="rId2"/>
          <a:srcRect l="4488" t="0" r="0" b="0"/>
          <a:stretch/>
        </p:blipFill>
        <p:spPr>
          <a:xfrm>
            <a:off x="2013120" y="3610080"/>
            <a:ext cx="3181320" cy="2987640"/>
          </a:xfrm>
          <a:prstGeom prst="rect">
            <a:avLst/>
          </a:prstGeom>
          <a:ln w="0">
            <a:noFill/>
          </a:ln>
        </p:spPr>
      </p:pic>
      <p:sp>
        <p:nvSpPr>
          <p:cNvPr id="94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3.2 – Inter-observer agreement analysis (Obs 1 vs Obs 3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Immagine 24" descr=""/>
          <p:cNvPicPr/>
          <p:nvPr/>
        </p:nvPicPr>
        <p:blipFill>
          <a:blip r:embed="rId3"/>
          <a:srcRect l="1372" t="0" r="0" b="0"/>
          <a:stretch/>
        </p:blipFill>
        <p:spPr>
          <a:xfrm>
            <a:off x="5162400" y="582480"/>
            <a:ext cx="3214800" cy="2934000"/>
          </a:xfrm>
          <a:prstGeom prst="rect">
            <a:avLst/>
          </a:prstGeom>
          <a:ln w="0">
            <a:noFill/>
          </a:ln>
        </p:spPr>
      </p:pic>
      <p:pic>
        <p:nvPicPr>
          <p:cNvPr id="96" name="Immagine 9" descr=""/>
          <p:cNvPicPr/>
          <p:nvPr/>
        </p:nvPicPr>
        <p:blipFill>
          <a:blip r:embed="rId4"/>
          <a:stretch/>
        </p:blipFill>
        <p:spPr>
          <a:xfrm>
            <a:off x="2013120" y="631800"/>
            <a:ext cx="3338280" cy="2879640"/>
          </a:xfrm>
          <a:prstGeom prst="rect">
            <a:avLst/>
          </a:prstGeom>
          <a:ln w="0">
            <a:noFill/>
          </a:ln>
        </p:spPr>
      </p:pic>
      <p:sp>
        <p:nvSpPr>
          <p:cNvPr id="97" name="TextBox 3"/>
          <p:cNvSpPr/>
          <p:nvPr/>
        </p:nvSpPr>
        <p:spPr>
          <a:xfrm>
            <a:off x="2013120" y="777960"/>
            <a:ext cx="28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ssing–Bablok Reg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2"/>
          <p:cNvSpPr/>
          <p:nvPr/>
        </p:nvSpPr>
        <p:spPr>
          <a:xfrm>
            <a:off x="5351400" y="777960"/>
            <a:ext cx="279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d Altman P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2"/>
          <p:cNvSpPr/>
          <p:nvPr/>
        </p:nvSpPr>
        <p:spPr>
          <a:xfrm>
            <a:off x="5348160" y="3753000"/>
            <a:ext cx="26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d Altman P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3"/>
          <p:cNvSpPr/>
          <p:nvPr/>
        </p:nvSpPr>
        <p:spPr>
          <a:xfrm>
            <a:off x="2013120" y="3755880"/>
            <a:ext cx="28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ssing–Bablok Reg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20"/>
          <p:cNvSpPr/>
          <p:nvPr/>
        </p:nvSpPr>
        <p:spPr>
          <a:xfrm>
            <a:off x="3230640" y="5665680"/>
            <a:ext cx="1931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0,51 (CI 95%: -2,45 – 3,0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0,97 (CI 95%: 0,91 – 1,0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21"/>
          <p:cNvSpPr/>
          <p:nvPr/>
        </p:nvSpPr>
        <p:spPr>
          <a:xfrm>
            <a:off x="3387600" y="2649600"/>
            <a:ext cx="225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-0,22 (CI 95%: -1,97 – 1,8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0,97 (CI 95%: 0,93 – 1,0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CasellaDiTesto 6"/>
          <p:cNvSpPr/>
          <p:nvPr/>
        </p:nvSpPr>
        <p:spPr>
          <a:xfrm>
            <a:off x="1300320" y="498600"/>
            <a:ext cx="7118280" cy="3070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BT M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CasellaDiTesto 6"/>
          <p:cNvSpPr/>
          <p:nvPr/>
        </p:nvSpPr>
        <p:spPr>
          <a:xfrm>
            <a:off x="1300320" y="3456000"/>
            <a:ext cx="7118280" cy="3070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BT TRU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itle 5"/>
          <p:cNvSpPr/>
          <p:nvPr/>
        </p:nvSpPr>
        <p:spPr>
          <a:xfrm>
            <a:off x="133200" y="6364440"/>
            <a:ext cx="9772920" cy="44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bbreviation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Obs: observer; CI: confidence interval.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Symbols </a:t>
            </a:r>
            <a:r>
              <a:rPr b="0" lang="mr-IN" sz="11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square: FIGO I; circle: FIGO II; triangle </a:t>
            </a:r>
            <a:r>
              <a:rPr b="0" lang="mr-IN" sz="11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FIGO III; diamond: FIGO IV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NOTE: in Bland Altman plot, solid line represents average, thick doted line represents 2SD (SD: standard deviation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Immagine 20" descr=""/>
          <p:cNvPicPr/>
          <p:nvPr/>
        </p:nvPicPr>
        <p:blipFill>
          <a:blip r:embed="rId1"/>
          <a:stretch/>
        </p:blipFill>
        <p:spPr>
          <a:xfrm>
            <a:off x="1727280" y="3637080"/>
            <a:ext cx="3295440" cy="2879640"/>
          </a:xfrm>
          <a:prstGeom prst="rect">
            <a:avLst/>
          </a:prstGeom>
          <a:ln w="0">
            <a:noFill/>
          </a:ln>
        </p:spPr>
      </p:pic>
      <p:pic>
        <p:nvPicPr>
          <p:cNvPr id="107" name="Immagine 23" descr=""/>
          <p:cNvPicPr/>
          <p:nvPr/>
        </p:nvPicPr>
        <p:blipFill>
          <a:blip r:embed="rId2"/>
          <a:stretch/>
        </p:blipFill>
        <p:spPr>
          <a:xfrm>
            <a:off x="5351400" y="3637080"/>
            <a:ext cx="3048120" cy="2879640"/>
          </a:xfrm>
          <a:prstGeom prst="rect">
            <a:avLst/>
          </a:prstGeom>
          <a:ln w="0">
            <a:noFill/>
          </a:ln>
        </p:spPr>
      </p:pic>
      <p:pic>
        <p:nvPicPr>
          <p:cNvPr id="108" name="Immagine 17" descr=""/>
          <p:cNvPicPr/>
          <p:nvPr/>
        </p:nvPicPr>
        <p:blipFill>
          <a:blip r:embed="rId3"/>
          <a:srcRect l="2424" t="0" r="0" b="0"/>
          <a:stretch/>
        </p:blipFill>
        <p:spPr>
          <a:xfrm>
            <a:off x="5157720" y="668160"/>
            <a:ext cx="2992680" cy="2880000"/>
          </a:xfrm>
          <a:prstGeom prst="rect">
            <a:avLst/>
          </a:prstGeom>
          <a:ln w="0">
            <a:noFill/>
          </a:ln>
        </p:spPr>
      </p:pic>
      <p:pic>
        <p:nvPicPr>
          <p:cNvPr id="109" name="Immagine 10" descr=""/>
          <p:cNvPicPr/>
          <p:nvPr/>
        </p:nvPicPr>
        <p:blipFill>
          <a:blip r:embed="rId4"/>
          <a:stretch/>
        </p:blipFill>
        <p:spPr>
          <a:xfrm>
            <a:off x="1922400" y="668160"/>
            <a:ext cx="3100320" cy="2880000"/>
          </a:xfrm>
          <a:prstGeom prst="rect">
            <a:avLst/>
          </a:prstGeom>
          <a:ln w="0">
            <a:noFill/>
          </a:ln>
        </p:spPr>
      </p:pic>
      <p:sp>
        <p:nvSpPr>
          <p:cNvPr id="110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3.3 – Inter-observer agreement analysis (Obs 2 vs Obs 3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3"/>
          <p:cNvSpPr/>
          <p:nvPr/>
        </p:nvSpPr>
        <p:spPr>
          <a:xfrm>
            <a:off x="2013120" y="777960"/>
            <a:ext cx="28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ssing–Bablok Reg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2"/>
          <p:cNvSpPr/>
          <p:nvPr/>
        </p:nvSpPr>
        <p:spPr>
          <a:xfrm>
            <a:off x="5351400" y="777960"/>
            <a:ext cx="279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d Altman P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2"/>
          <p:cNvSpPr/>
          <p:nvPr/>
        </p:nvSpPr>
        <p:spPr>
          <a:xfrm>
            <a:off x="5348160" y="3753000"/>
            <a:ext cx="26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nd Altman P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3"/>
          <p:cNvSpPr/>
          <p:nvPr/>
        </p:nvSpPr>
        <p:spPr>
          <a:xfrm>
            <a:off x="2013120" y="3755880"/>
            <a:ext cx="28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ssing–Bablok Reg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28"/>
          <p:cNvSpPr/>
          <p:nvPr/>
        </p:nvSpPr>
        <p:spPr>
          <a:xfrm>
            <a:off x="3166920" y="5649840"/>
            <a:ext cx="1857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2,7 (CI 95%: -2,53 </a:t>
            </a:r>
            <a:r>
              <a:rPr b="0" lang="mr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–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7,29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0,94 (CI 95%: 0,82 </a:t>
            </a:r>
            <a:r>
              <a:rPr b="0" lang="mr-I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–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1,08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29"/>
          <p:cNvSpPr/>
          <p:nvPr/>
        </p:nvSpPr>
        <p:spPr>
          <a:xfrm>
            <a:off x="3192480" y="2633760"/>
            <a:ext cx="1830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rcep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1,42 (CI 95%: -1,69 – 4,93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ope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0,96 (CI 95%: 0,88 – 1,0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CasellaDiTesto 6"/>
          <p:cNvSpPr/>
          <p:nvPr/>
        </p:nvSpPr>
        <p:spPr>
          <a:xfrm>
            <a:off x="1300320" y="498600"/>
            <a:ext cx="7118280" cy="3070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BT M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CasellaDiTesto 6"/>
          <p:cNvSpPr/>
          <p:nvPr/>
        </p:nvSpPr>
        <p:spPr>
          <a:xfrm>
            <a:off x="1300320" y="3456000"/>
            <a:ext cx="7118280" cy="3070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BT TRU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itle 5"/>
          <p:cNvSpPr/>
          <p:nvPr/>
        </p:nvSpPr>
        <p:spPr>
          <a:xfrm>
            <a:off x="133200" y="6364440"/>
            <a:ext cx="9772920" cy="44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bbreviation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Obs: observer; CI: confidence interval.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Symbols </a:t>
            </a:r>
            <a:r>
              <a:rPr b="0" lang="mr-IN" sz="11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square: FIGO I; circle: FIGO II; triangle </a:t>
            </a:r>
            <a:r>
              <a:rPr b="0" lang="mr-IN" sz="1100" spc="-1" strike="noStrike">
                <a:solidFill>
                  <a:srgbClr val="000000"/>
                </a:solidFill>
                <a:latin typeface="Arial"/>
                <a:ea typeface="Arial"/>
              </a:rPr>
              <a:t>–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FIGO III; diamond: FIGO IV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NOTE: in Bland Altman plot, solid line represents average, thick doted line represents 2SD (SD: standard deviation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Title 5"/>
          <p:cNvSpPr/>
          <p:nvPr/>
        </p:nvSpPr>
        <p:spPr>
          <a:xfrm>
            <a:off x="0" y="38160"/>
            <a:ext cx="9906120" cy="395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Supplement 4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1" name="Picture 1" descr="Screen Shot 2019-01-18 at 18.20.00.png"/>
          <p:cNvPicPr/>
          <p:nvPr/>
        </p:nvPicPr>
        <p:blipFill>
          <a:blip r:embed="rId1"/>
          <a:stretch/>
        </p:blipFill>
        <p:spPr>
          <a:xfrm>
            <a:off x="349200" y="647640"/>
            <a:ext cx="6381720" cy="5742000"/>
          </a:xfrm>
          <a:prstGeom prst="rect">
            <a:avLst/>
          </a:prstGeom>
          <a:ln w="0">
            <a:noFill/>
          </a:ln>
        </p:spPr>
      </p:pic>
      <p:sp>
        <p:nvSpPr>
          <p:cNvPr id="122" name="TextBox 2"/>
          <p:cNvSpPr/>
          <p:nvPr/>
        </p:nvSpPr>
        <p:spPr>
          <a:xfrm>
            <a:off x="6896160" y="5143680"/>
            <a:ext cx="28065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Example of a large FIGO IIIB squamous cell cervical cancer,  with extensive infiltration of parametria and pelvic wall (white arrows).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30T08:54:40Z</dcterms:created>
  <dc:creator>mario federico</dc:creator>
  <dc:description/>
  <dc:language>en-US</dc:language>
  <cp:lastModifiedBy>mario federico</cp:lastModifiedBy>
  <cp:lastPrinted>2017-03-20T20:08:20Z</cp:lastPrinted>
  <dcterms:modified xsi:type="dcterms:W3CDTF">2019-02-24T17:20:39Z</dcterms:modified>
  <cp:revision>104</cp:revision>
  <dc:subject/>
  <dc:title>Obs 1 intra observer</dc:title>
</cp:coreProperties>
</file>